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8" r:id="rId3"/>
    <p:sldId id="262" r:id="rId4"/>
    <p:sldId id="263" r:id="rId5"/>
    <p:sldId id="261" r:id="rId6"/>
  </p:sldIdLst>
  <p:sldSz cx="9144000" cy="6858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eronique Douard" initials="VD" lastIdx="0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B76D6-C61B-4C13-A772-F06940E9B2FD}" type="datetimeFigureOut">
              <a:rPr lang="fr-FR" smtClean="0"/>
              <a:pPr/>
              <a:t>28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19853-2380-4AD5-86E6-F6D348C3DCB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52"/>
          <a:stretch/>
        </p:blipFill>
        <p:spPr>
          <a:xfrm>
            <a:off x="5580112" y="1628800"/>
            <a:ext cx="2736304" cy="2563368"/>
          </a:xfrm>
          <a:prstGeom prst="rect">
            <a:avLst/>
          </a:prstGeom>
        </p:spPr>
      </p:pic>
      <p:sp>
        <p:nvSpPr>
          <p:cNvPr id="3" name="ZoneTexte 6">
            <a:extLst>
              <a:ext uri="{FF2B5EF4-FFF2-40B4-BE49-F238E27FC236}">
                <a16:creationId xmlns:a16="http://schemas.microsoft.com/office/drawing/2014/main" id="{7D83D576-E027-4F54-B4A0-F3FBFA704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9274" y="648333"/>
            <a:ext cx="7713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/>
              <a:t>Fig. </a:t>
            </a:r>
            <a:r>
              <a:rPr lang="fr-FR" altLang="zh-CN" sz="1400" b="1" dirty="0" smtClean="0"/>
              <a:t>S1</a:t>
            </a:r>
            <a:endParaRPr lang="fr-FR" altLang="zh-CN" sz="1400" b="1" dirty="0"/>
          </a:p>
        </p:txBody>
      </p:sp>
      <p:sp>
        <p:nvSpPr>
          <p:cNvPr id="4" name="ZoneTexte 6">
            <a:extLst>
              <a:ext uri="{FF2B5EF4-FFF2-40B4-BE49-F238E27FC236}">
                <a16:creationId xmlns:a16="http://schemas.microsoft.com/office/drawing/2014/main" id="{7D83D576-E027-4F54-B4A0-F3FBFA704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1840" y="116632"/>
            <a:ext cx="212429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 err="1" smtClean="0">
                <a:cs typeface="Arial" panose="020B0604020202020204" pitchFamily="34" charset="0"/>
              </a:rPr>
              <a:t>Supplementary</a:t>
            </a:r>
            <a:r>
              <a:rPr lang="fr-FR" altLang="zh-CN" sz="1400" b="1" dirty="0" smtClean="0">
                <a:cs typeface="Arial" panose="020B0604020202020204" pitchFamily="34" charset="0"/>
              </a:rPr>
              <a:t> figures</a:t>
            </a:r>
            <a:endParaRPr lang="fr-FR" altLang="zh-CN" sz="1400" b="1" dirty="0">
              <a:cs typeface="Arial" panose="020B0604020202020204" pitchFamily="34" charset="0"/>
            </a:endParaRPr>
          </a:p>
        </p:txBody>
      </p:sp>
      <p:sp>
        <p:nvSpPr>
          <p:cNvPr id="5" name="ZoneTexte 6">
            <a:extLst>
              <a:ext uri="{FF2B5EF4-FFF2-40B4-BE49-F238E27FC236}">
                <a16:creationId xmlns:a16="http://schemas.microsoft.com/office/drawing/2014/main" id="{7D83D576-E027-4F54-B4A0-F3FBFA704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40152" y="1177007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 smtClean="0">
                <a:cs typeface="Arial" panose="020B0604020202020204" pitchFamily="34" charset="0"/>
              </a:rPr>
              <a:t>B</a:t>
            </a:r>
            <a:endParaRPr lang="fr-FR" altLang="zh-CN" sz="1400" b="1" dirty="0"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6732240" y="1398216"/>
            <a:ext cx="881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ecum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11"/>
          <a:stretch/>
        </p:blipFill>
        <p:spPr>
          <a:xfrm>
            <a:off x="717886" y="1628800"/>
            <a:ext cx="2918010" cy="2563368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1902130" y="1398216"/>
            <a:ext cx="920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ejunum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786" t="327" r="-1092" b="46627"/>
          <a:stretch/>
        </p:blipFill>
        <p:spPr>
          <a:xfrm>
            <a:off x="3995936" y="1844824"/>
            <a:ext cx="1146498" cy="1359768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1336892" y="5282216"/>
            <a:ext cx="61744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"/>
          <p:cNvSpPr txBox="1"/>
          <p:nvPr/>
        </p:nvSpPr>
        <p:spPr>
          <a:xfrm>
            <a:off x="539552" y="5076381"/>
            <a:ext cx="80648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cose and fructos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porter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junum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cum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rmaliz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control group. All values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± SEM;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8/grou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Dunn multipl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 *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ﬁcan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ﬀerenc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s (* p &lt;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, ***p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1 and **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001)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1297684" y="1177007"/>
            <a:ext cx="3575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</a:p>
        </p:txBody>
      </p:sp>
    </p:spTree>
    <p:extLst>
      <p:ext uri="{BB962C8B-B14F-4D97-AF65-F5344CB8AC3E}">
        <p14:creationId xmlns:p14="http://schemas.microsoft.com/office/powerpoint/2010/main" val="3733860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"/>
          <p:cNvSpPr txBox="1"/>
          <p:nvPr/>
        </p:nvSpPr>
        <p:spPr>
          <a:xfrm>
            <a:off x="188870" y="5373216"/>
            <a:ext cx="80648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glucose and fructose on barrier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nction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co-2BB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differentiated 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wel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17 days afte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luence in 25mM glucose DMEM. After, 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cultured for 24h in presence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mM glucose (G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m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uctose (F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 glucose or 1m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ctose DMEM before exposure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kines (D0 to D1). Then, the cells were treated, in presence of glucose or fructose with 10ng/m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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basal chamber for 24 hour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1 to D2) prior exposure to TNF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50ng/mL) at D2. Then TEER was measured every hours for 5 hour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values are means ± SEM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3-8/group.</a:t>
            </a:r>
            <a:endParaRPr lang="fr-FR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e 1"/>
          <p:cNvGrpSpPr/>
          <p:nvPr/>
        </p:nvGrpSpPr>
        <p:grpSpPr>
          <a:xfrm>
            <a:off x="539552" y="393593"/>
            <a:ext cx="8132280" cy="4930881"/>
            <a:chOff x="539552" y="393593"/>
            <a:chExt cx="8132280" cy="4930881"/>
          </a:xfrm>
        </p:grpSpPr>
        <p:sp>
          <p:nvSpPr>
            <p:cNvPr id="3" name="ZoneTexte 6">
              <a:extLst>
                <a:ext uri="{FF2B5EF4-FFF2-40B4-BE49-F238E27FC236}">
                  <a16:creationId xmlns:a16="http://schemas.microsoft.com/office/drawing/2014/main" id="{7D83D576-E027-4F54-B4A0-F3FBFA704A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9552" y="393593"/>
              <a:ext cx="77136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FR" altLang="zh-CN" sz="1400" b="1" dirty="0"/>
                <a:t>Fig. </a:t>
              </a:r>
              <a:r>
                <a:rPr lang="fr-FR" altLang="zh-CN" sz="1400" b="1" dirty="0" smtClean="0"/>
                <a:t>S2</a:t>
              </a:r>
              <a:endParaRPr lang="fr-FR" altLang="zh-CN" sz="1400" b="1" dirty="0"/>
            </a:p>
          </p:txBody>
        </p:sp>
        <p:pic>
          <p:nvPicPr>
            <p:cNvPr id="1026" name="Picture 2" descr="F:\ressoumsion frontiers\figure jpeg\supTEERbis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25234" y="1124744"/>
              <a:ext cx="7746598" cy="41997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-2677" y="2467475"/>
              <a:ext cx="16802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ized TEER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600" y="1268760"/>
            <a:ext cx="2798307" cy="1999661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755650" y="4149080"/>
            <a:ext cx="705671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esulfovibri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genus abundanc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ssessed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n the caecum content of the 3 groups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ell count/gram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aeca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content are represented for each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oups. Value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re means ± SEMs (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=6-8/grou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 Means were compar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Kruska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Wallis test followed by Dunn multiple comparison test. * indicates signiﬁcant diﬀerences among groups (* p &lt; 0.05). </a:t>
            </a:r>
            <a:endParaRPr lang="fr-FR" sz="1200" dirty="0"/>
          </a:p>
        </p:txBody>
      </p:sp>
      <p:sp>
        <p:nvSpPr>
          <p:cNvPr id="4" name="ZoneTexte 6">
            <a:extLst>
              <a:ext uri="{FF2B5EF4-FFF2-40B4-BE49-F238E27FC236}">
                <a16:creationId xmlns:a16="http://schemas.microsoft.com/office/drawing/2014/main" id="{7D83D576-E027-4F54-B4A0-F3FBFA704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528935"/>
            <a:ext cx="7713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/>
              <a:t>Fig. </a:t>
            </a:r>
            <a:r>
              <a:rPr lang="fr-FR" altLang="zh-CN" sz="1400" b="1" dirty="0" smtClean="0"/>
              <a:t>S3</a:t>
            </a:r>
            <a:endParaRPr lang="fr-FR" altLang="zh-CN" sz="1400" b="1" dirty="0"/>
          </a:p>
        </p:txBody>
      </p:sp>
    </p:spTree>
    <p:extLst>
      <p:ext uri="{BB962C8B-B14F-4D97-AF65-F5344CB8AC3E}">
        <p14:creationId xmlns:p14="http://schemas.microsoft.com/office/powerpoint/2010/main" val="1817322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5076381"/>
            <a:ext cx="81369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rate of  bacteria cultured in glucose (red) or fructose (green) enriched medium. Bacteria were selected based on their changes in relative abundanc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response to glucose or fructose intake.  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tbacillu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hnsonii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teroid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ulgatu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growth measurement was bas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readings of OD 660 n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ulfovibri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ulgari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growth measurement was based on qPCR analysi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tions.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234277" y="473593"/>
            <a:ext cx="8849690" cy="3954718"/>
            <a:chOff x="234277" y="473593"/>
            <a:chExt cx="8849690" cy="3954718"/>
          </a:xfrm>
        </p:grpSpPr>
        <p:sp>
          <p:nvSpPr>
            <p:cNvPr id="9" name="ZoneTexte 6">
              <a:extLst>
                <a:ext uri="{FF2B5EF4-FFF2-40B4-BE49-F238E27FC236}">
                  <a16:creationId xmlns:a16="http://schemas.microsoft.com/office/drawing/2014/main" id="{7D83D576-E027-4F54-B4A0-F3FBFA704A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77265" y="497536"/>
              <a:ext cx="77136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fr-FR" altLang="zh-CN" sz="1400" b="1" dirty="0"/>
                <a:t>Fig. </a:t>
              </a:r>
              <a:r>
                <a:rPr lang="fr-FR" altLang="zh-CN" sz="1400" b="1" dirty="0" smtClean="0"/>
                <a:t>S4</a:t>
              </a:r>
              <a:endParaRPr lang="fr-FR" altLang="zh-CN" sz="1400" b="1" dirty="0"/>
            </a:p>
          </p:txBody>
        </p:sp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8503"/>
            <a:stretch/>
          </p:blipFill>
          <p:spPr>
            <a:xfrm>
              <a:off x="234277" y="1260163"/>
              <a:ext cx="2393507" cy="3144206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73949" y="1260164"/>
              <a:ext cx="2374115" cy="3168147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214" t="13198" r="875" b="67004"/>
            <a:stretch/>
          </p:blipFill>
          <p:spPr>
            <a:xfrm>
              <a:off x="4569852" y="473593"/>
              <a:ext cx="1008112" cy="648072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866"/>
            <a:stretch/>
          </p:blipFill>
          <p:spPr>
            <a:xfrm>
              <a:off x="5073908" y="1908234"/>
              <a:ext cx="4010059" cy="2277251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69" t="4721" r="21773" b="87013"/>
            <a:stretch/>
          </p:blipFill>
          <p:spPr>
            <a:xfrm>
              <a:off x="5868144" y="1383543"/>
              <a:ext cx="2376264" cy="216024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>
              <a:off x="6312380" y="4046985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cose</a:t>
              </a:r>
              <a:endParaRPr lang="fr-F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7607100" y="4046985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uctose</a:t>
              </a:r>
              <a:endParaRPr lang="fr-F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33192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39552" y="5733256"/>
            <a:ext cx="66967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tt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of horizontal sparse partial leas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quares discriminant analy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c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onfidenc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lipse plo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tt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for operational taxonom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ts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OTU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cluster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656392" y="5085094"/>
            <a:ext cx="7872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1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 rot="16200000">
            <a:off x="1724610" y="2603982"/>
            <a:ext cx="7872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ariant 2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6">
            <a:extLst>
              <a:ext uri="{FF2B5EF4-FFF2-40B4-BE49-F238E27FC236}">
                <a16:creationId xmlns:a16="http://schemas.microsoft.com/office/drawing/2014/main" id="{7D83D576-E027-4F54-B4A0-F3FBFA704A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650" y="528935"/>
            <a:ext cx="7713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SimSun" panose="02010600030101010101" pitchFamily="2" charset="-122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altLang="zh-CN" sz="1400" b="1" dirty="0"/>
              <a:t>Fig. </a:t>
            </a:r>
            <a:r>
              <a:rPr lang="fr-FR" altLang="zh-CN" sz="1400" b="1" dirty="0" smtClean="0"/>
              <a:t>S5</a:t>
            </a:r>
            <a:endParaRPr lang="fr-FR" altLang="zh-CN" sz="1400" b="1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87" t="9385" b="2973"/>
          <a:stretch/>
        </p:blipFill>
        <p:spPr>
          <a:xfrm>
            <a:off x="2483768" y="1109833"/>
            <a:ext cx="3020481" cy="3963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449324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06</TotalTime>
  <Words>409</Words>
  <Application>Microsoft Office PowerPoint</Application>
  <PresentationFormat>Affichage à l'écran (4:3)</PresentationFormat>
  <Paragraphs>20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2" baseType="lpstr">
      <vt:lpstr>宋体</vt:lpstr>
      <vt:lpstr>宋体</vt:lpstr>
      <vt:lpstr>Arial</vt:lpstr>
      <vt:lpstr>Calibri</vt:lpstr>
      <vt:lpstr>Symbol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vedouard</dc:creator>
  <cp:lastModifiedBy>Veronique Douard</cp:lastModifiedBy>
  <cp:revision>56</cp:revision>
  <cp:lastPrinted>2021-09-29T08:15:39Z</cp:lastPrinted>
  <dcterms:created xsi:type="dcterms:W3CDTF">2018-08-30T14:08:19Z</dcterms:created>
  <dcterms:modified xsi:type="dcterms:W3CDTF">2021-10-28T14:18:37Z</dcterms:modified>
</cp:coreProperties>
</file>